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8AD8"/>
    <a:srgbClr val="FF66FF"/>
    <a:srgbClr val="9437FF"/>
    <a:srgbClr val="FFFD78"/>
    <a:srgbClr val="FFD579"/>
    <a:srgbClr val="FF7E79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4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00" y="11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804602" y="4915065"/>
            <a:ext cx="612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b="1" dirty="0">
                <a:latin typeface="Times New Roman"/>
                <a:cs typeface="Times New Roman"/>
              </a:rPr>
              <a:t>Figure S4. </a:t>
            </a:r>
            <a:r>
              <a:rPr lang="en-US" sz="1200" b="1" dirty="0">
                <a:latin typeface="Times New Roman"/>
                <a:cs typeface="Times New Roman"/>
              </a:rPr>
              <a:t>Structure of the CRISPR array of 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 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en-US" sz="1200" b="1" dirty="0">
                <a:latin typeface="Times New Roman"/>
                <a:cs typeface="Times New Roman"/>
              </a:rPr>
              <a:t> strains LB302, LB305 and LG115.</a:t>
            </a:r>
            <a:r>
              <a:rPr lang="en-US" sz="1200" dirty="0">
                <a:latin typeface="Times New Roman"/>
                <a:cs typeface="Times New Roman"/>
              </a:rPr>
              <a:t> Red characters indicate direct repeat sequences,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NP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underlined</a:t>
            </a:r>
            <a:r>
              <a:rPr lang="en-US" sz="1200" dirty="0">
                <a:latin typeface="Times New Roman"/>
                <a:cs typeface="Times New Roman"/>
              </a:rPr>
              <a:t>. Blue characters indicate spacer sequences. 6 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tgaaac</a:t>
            </a:r>
            <a:r>
              <a:rPr lang="en-US" sz="1200" dirty="0">
                <a:latin typeface="Times New Roman"/>
                <a:cs typeface="Times New Roman"/>
              </a:rPr>
              <a:t>) in green boxes represent the target site duplication. Pink boxes represent the inverted repeats (28 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). Blue boxes represent base pairs that do not match within the inverted repeat</a:t>
            </a:r>
            <a:r>
              <a:rPr lang="en-US" sz="1200" dirty="0"/>
              <a:t>s. </a:t>
            </a:r>
            <a:endParaRPr lang="fr-FR" sz="1200" dirty="0"/>
          </a:p>
        </p:txBody>
      </p:sp>
      <p:sp useBgFill="1">
        <p:nvSpPr>
          <p:cNvPr id="2" name="Rectangle 1"/>
          <p:cNvSpPr/>
          <p:nvPr/>
        </p:nvSpPr>
        <p:spPr>
          <a:xfrm>
            <a:off x="1804602" y="737927"/>
            <a:ext cx="6120000" cy="406800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aatgctttcgacgcgcataaagcgctggcgcagg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ttcaagctccgccgcctgatccgcttgccg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cgggtttcgggatgtgcttcagatctgcgtc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</a:t>
            </a:r>
            <a:r>
              <a:rPr lang="en-US" sz="900" dirty="0" err="1">
                <a:solidFill>
                  <a:srgbClr val="FF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aaac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cga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aa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cccac</a:t>
            </a:r>
            <a:endParaRPr lang="en-US" sz="900" dirty="0">
              <a:highlight>
                <a:srgbClr val="FF00FF"/>
              </a:highlight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 err="1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gcgccgaagtaaaagtga</a:t>
            </a:r>
            <a:endParaRPr lang="en-US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endParaRPr lang="en-US" sz="900" dirty="0">
              <a:highlight>
                <a:srgbClr val="FF00FF"/>
              </a:highlight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... IS element ...</a:t>
            </a:r>
          </a:p>
          <a:p>
            <a:endParaRPr lang="en-US" sz="900" dirty="0">
              <a:highlight>
                <a:srgbClr val="FF00FF"/>
              </a:highlight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r>
              <a:rPr lang="en-US" sz="900" dirty="0" err="1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tcggcgatccaacgaaaa</a:t>
            </a:r>
            <a:endParaRPr lang="en-US" sz="900" dirty="0">
              <a:highlight>
                <a:srgbClr val="FF00FF"/>
              </a:highlight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gggtcag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t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tcggcg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ca</a:t>
            </a:r>
            <a:r>
              <a:rPr lang="en-US" sz="900" dirty="0" err="1">
                <a:solidFill>
                  <a:srgbClr val="FF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tgcacggatgcgccaggcggcgaggcgatca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0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agcgcatcgatgacggtcacccatcccccaat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9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gccaccgacagcgacgcacgtggacctgcagat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8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ctctcacgccgcgcgtgcgagatcctgcgt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7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agactgccgaggccggcatgctggaggggcgcc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6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gttaacaacgccttgaaacggctttgccgcgac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5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catcatgctttgaatgcgcttacccacggc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ggatatgtgattagacccttttacgactttc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tgtcgaaaacgatggccttgacgtcatcgtct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cgctggcatcggtggatggagccttgcgcttc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0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attgaacccaaggaccacttcgcagggcgac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9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gaccacatgttctctctgtgggaggaaggca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8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tcgagcgcgcactgctgccgcgatggccg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7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ctgggagcgttacaagtttgagcagcccgt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6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gttcagggctggaaagacttggatgcccgcat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5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ctatccctgcataggccacgacctgcgag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4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agaagaccagtctgcggcgtcgcggcatcctggg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gttcgtcgccgtcccggtcgtctgacgcg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u="sng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cgccctca</a:t>
            </a:r>
            <a:r>
              <a:rPr lang="en-US" sz="900" u="sng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atgccatatgcggcgagatcgcacagcagaag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)</a:t>
            </a:r>
          </a:p>
          <a:p>
            <a:pPr>
              <a:spcAft>
                <a:spcPts val="0"/>
              </a:spcAft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u="sng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gccctcacgggcgcgtggattgaaac</a:t>
            </a:r>
            <a:endParaRPr lang="en-US" sz="900" dirty="0">
              <a:solidFill>
                <a:srgbClr val="FF0000"/>
              </a:solidFill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48351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9</TotalTime>
  <Words>176</Words>
  <Application>Microsoft Macintosh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Malgun Gothic</vt:lpstr>
      <vt:lpstr>Arial</vt:lpstr>
      <vt:lpstr>Calibri</vt:lpstr>
      <vt:lpstr>Calibri Light</vt:lpstr>
      <vt:lpstr>Courier New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31</cp:revision>
  <cp:lastPrinted>2018-08-27T13:01:04Z</cp:lastPrinted>
  <dcterms:created xsi:type="dcterms:W3CDTF">2018-03-26T14:17:04Z</dcterms:created>
  <dcterms:modified xsi:type="dcterms:W3CDTF">2019-11-04T14:10:06Z</dcterms:modified>
</cp:coreProperties>
</file>